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sldIdLst>
    <p:sldId id="257" r:id="rId5"/>
    <p:sldId id="258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7"/>
    <p:restoredTop sz="95246"/>
  </p:normalViewPr>
  <p:slideViewPr>
    <p:cSldViewPr snapToGrid="0" snapToObjects="1">
      <p:cViewPr varScale="1">
        <p:scale>
          <a:sx n="120" d="100"/>
          <a:sy n="120" d="100"/>
        </p:scale>
        <p:origin x="114" y="2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4CCC6E-789E-0F48-97E2-903BC2E92ED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8C68211-1DB0-B342-992E-B1697A9D663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188AC3-2159-044F-97B7-228AD45CFA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03302-94B9-D545-AF18-7726EAEAF069}" type="datetimeFigureOut">
              <a:rPr lang="en-US" smtClean="0"/>
              <a:t>10/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C45496-F7EC-5146-93BE-5FFD997838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82B5DC-8578-EA44-AE26-2B66214292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8341B7-DB54-B247-918C-3A182AD490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62010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622382-AA6D-E141-BF68-6B401A3200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2ECF543-117C-AC49-8236-DEAF275240E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9B2A7C-26CE-7E42-BEA5-7DD0D4D763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03302-94B9-D545-AF18-7726EAEAF069}" type="datetimeFigureOut">
              <a:rPr lang="en-US" smtClean="0"/>
              <a:t>10/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DF31A9-80D6-2A40-B36A-E82F59DBBB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26F1FD-6205-7045-904A-DCA9EDCCD2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8341B7-DB54-B247-918C-3A182AD490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85706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44E7B7F-094F-754C-841F-114DFF1D0CD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34222C4-A6BE-2F4D-8904-6DE40B50A03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51F80F-E5DB-8240-9370-C85E0B1D68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03302-94B9-D545-AF18-7726EAEAF069}" type="datetimeFigureOut">
              <a:rPr lang="en-US" smtClean="0"/>
              <a:t>10/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A5FBE7-161B-494B-A243-5BD9115F41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3CFEF0-ACC4-6541-B7D4-50D62B3192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8341B7-DB54-B247-918C-3A182AD490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27311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CF2FAA-CB99-E04D-97A7-F47A367DDD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5943730-96BE-454C-BD2B-9AC6147C662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6F99B1-9A84-474E-8FEE-FAEF56F6F0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03302-94B9-D545-AF18-7726EAEAF069}" type="datetimeFigureOut">
              <a:rPr lang="en-US" smtClean="0"/>
              <a:t>10/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D94D37-406A-2040-AA16-07EAB986E2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9341AF-41B4-0C43-897A-F13EF297B8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8341B7-DB54-B247-918C-3A182AD490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16416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A88B86-4DB6-4D4B-BE1D-10234C48E5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F3EBF41-CF18-704D-AE77-D3988AA446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C44D68-E1E1-544E-B98A-3189C173B1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03302-94B9-D545-AF18-7726EAEAF069}" type="datetimeFigureOut">
              <a:rPr lang="en-US" smtClean="0"/>
              <a:t>10/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29F5F3-5804-DC45-8BC4-6FF38F1990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C66D6B-569F-D44D-B545-CCD798A4AC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8341B7-DB54-B247-918C-3A182AD490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37331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578FE5-6D88-3646-8431-8E009F901F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A041A54-AD75-074C-A23D-A275F44AF56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5177DCA-7029-8B48-89A3-0182F9673D2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78CE3E8-4DD8-AD40-A43C-95C1319515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03302-94B9-D545-AF18-7726EAEAF069}" type="datetimeFigureOut">
              <a:rPr lang="en-US" smtClean="0"/>
              <a:t>10/6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FE34E48-49B4-414F-A284-DE134F5525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E03D4FD-B80F-B94B-AFFE-92B154694B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8341B7-DB54-B247-918C-3A182AD490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51565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2DF220-83E9-1A42-B0BF-A99E272568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5C58F93-6CB3-1749-B49E-477F1B9177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FA687AD-CBF0-0642-A939-42DBCC8CF3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9F012A0-C0C8-9F45-A340-997A83B9EDD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94AB4F7-1223-BE49-96C9-CEEDF6FB1A0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10A98E1-2842-9F4C-B369-D22CE453D5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03302-94B9-D545-AF18-7726EAEAF069}" type="datetimeFigureOut">
              <a:rPr lang="en-US" smtClean="0"/>
              <a:t>10/6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A2505D8-3ABC-A043-BD26-61BD7439D8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EBFD4DA-DCFA-9440-9DC6-ACEDCB896D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8341B7-DB54-B247-918C-3A182AD490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65952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B5D744-9A2E-1346-9A14-765B9240C3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0E78CD3-9AF4-654D-A651-21D5ADDB98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03302-94B9-D545-AF18-7726EAEAF069}" type="datetimeFigureOut">
              <a:rPr lang="en-US" smtClean="0"/>
              <a:t>10/6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999785D-9FC5-3A4D-A086-CE6C2B5046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266ECBA-AAED-724D-B1A7-F547869D17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8341B7-DB54-B247-918C-3A182AD490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46144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A7331C7-3AF8-8F4D-AF78-434750B601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03302-94B9-D545-AF18-7726EAEAF069}" type="datetimeFigureOut">
              <a:rPr lang="en-US" smtClean="0"/>
              <a:t>10/6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77D76D3-ECE4-6248-82DF-43CBD79C99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D8EAA4C-F3A7-8E48-B8B8-5772D3892B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8341B7-DB54-B247-918C-3A182AD490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62318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7C1515-08D4-7B41-B5C7-DE29E4DE0E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88B1DF2-E726-4643-B9F6-21973E9CA6B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310F9A6-88EE-D345-A7E3-18C20EC2F4B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A502BEA-C8F9-E843-809A-FFA9B6E55F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03302-94B9-D545-AF18-7726EAEAF069}" type="datetimeFigureOut">
              <a:rPr lang="en-US" smtClean="0"/>
              <a:t>10/6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49877E7-0D14-6F44-B865-F83D4CA3BD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3D524C5-401C-614B-8D41-6DD7780E07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8341B7-DB54-B247-918C-3A182AD490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35961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801600-7BA0-F643-AFC0-E4130E1330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DC42AA8-F2F0-F14C-AD02-BBE66E556D8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277AA17-FD26-9F46-B24B-6F90629869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02F1088-8314-244E-BB2C-114C91CFFF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03302-94B9-D545-AF18-7726EAEAF069}" type="datetimeFigureOut">
              <a:rPr lang="en-US" smtClean="0"/>
              <a:t>10/6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6662412-6A97-C742-AEBD-172B26EAFC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3DFD9AD-E702-A641-A723-43C51D7F8E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8341B7-DB54-B247-918C-3A182AD490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17380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08D886B-1B9E-A948-BBE2-44A6BE4992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261556A-5E13-C541-BC0B-E6207CAF37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6AAFC8-1650-C945-9427-7CFD978976D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103302-94B9-D545-AF18-7726EAEAF069}" type="datetimeFigureOut">
              <a:rPr lang="en-US" smtClean="0"/>
              <a:t>10/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166CF5-1E0F-AD43-A681-CF28C9A6982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AAE3D6-B7AE-3646-99DD-5D3C2B6B48D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8341B7-DB54-B247-918C-3A182AD490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40675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F3639785-222A-4A49-A172-45CB17F9971B}"/>
              </a:ext>
            </a:extLst>
          </p:cNvPr>
          <p:cNvSpPr/>
          <p:nvPr/>
        </p:nvSpPr>
        <p:spPr>
          <a:xfrm>
            <a:off x="209685" y="3228885"/>
            <a:ext cx="59227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α</a:t>
            </a:r>
            <a:r>
              <a:rPr lang="en-US" sz="1200" dirty="0">
                <a:solidFill>
                  <a:prstClr val="black"/>
                </a:solidFill>
                <a:cs typeface="Arial" panose="020B0604020202020204" pitchFamily="34" charset="0"/>
              </a:rPr>
              <a:t>FLAG</a:t>
            </a:r>
            <a:endParaRPr lang="en-US" sz="1200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0B65ACC3-98D7-3242-B314-4759C16408E5}"/>
              </a:ext>
            </a:extLst>
          </p:cNvPr>
          <p:cNvSpPr txBox="1"/>
          <p:nvPr/>
        </p:nvSpPr>
        <p:spPr>
          <a:xfrm>
            <a:off x="4517643" y="3141623"/>
            <a:ext cx="11584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ytTM-SpoIVFB</a:t>
            </a:r>
            <a:r>
              <a:rPr lang="en-US" sz="1200" baseline="30000" dirty="0"/>
              <a:t> </a:t>
            </a:r>
            <a:endParaRPr lang="en-US" sz="1200" dirty="0"/>
          </a:p>
        </p:txBody>
      </p: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A5F83EB0-658C-534A-9D70-0CCEC793AE1E}"/>
              </a:ext>
            </a:extLst>
          </p:cNvPr>
          <p:cNvCxnSpPr>
            <a:cxnSpLocks/>
          </p:cNvCxnSpPr>
          <p:nvPr/>
        </p:nvCxnSpPr>
        <p:spPr>
          <a:xfrm flipH="1">
            <a:off x="4415891" y="3280123"/>
            <a:ext cx="175399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3" name="Rectangle 42">
            <a:extLst>
              <a:ext uri="{FF2B5EF4-FFF2-40B4-BE49-F238E27FC236}">
                <a16:creationId xmlns:a16="http://schemas.microsoft.com/office/drawing/2014/main" id="{7B77CE35-F2FA-2C4E-8B02-71CEDDCCD6A9}"/>
              </a:ext>
            </a:extLst>
          </p:cNvPr>
          <p:cNvSpPr/>
          <p:nvPr/>
        </p:nvSpPr>
        <p:spPr>
          <a:xfrm>
            <a:off x="6429953" y="3280122"/>
            <a:ext cx="46358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α</a:t>
            </a:r>
            <a:r>
              <a:rPr lang="en-US" sz="1200" dirty="0">
                <a:solidFill>
                  <a:prstClr val="black"/>
                </a:solidFill>
                <a:cs typeface="Arial" panose="020B0604020202020204" pitchFamily="34" charset="0"/>
              </a:rPr>
              <a:t>His</a:t>
            </a:r>
            <a:endParaRPr lang="en-US" sz="1200" dirty="0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4D96F7ED-AA87-D647-B095-DBC60F415BDF}"/>
              </a:ext>
            </a:extLst>
          </p:cNvPr>
          <p:cNvSpPr txBox="1"/>
          <p:nvPr/>
        </p:nvSpPr>
        <p:spPr>
          <a:xfrm>
            <a:off x="10609209" y="3794465"/>
            <a:ext cx="10317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ro-</a:t>
            </a:r>
            <a:r>
              <a:rPr lang="en-US" sz="1200" dirty="0" err="1"/>
              <a:t>σ</a:t>
            </a:r>
            <a:r>
              <a:rPr lang="en-US" sz="1200" baseline="30000" dirty="0" err="1"/>
              <a:t>K</a:t>
            </a:r>
            <a:r>
              <a:rPr lang="en-US" sz="1200" dirty="0"/>
              <a:t>(1-127)</a:t>
            </a:r>
          </a:p>
        </p:txBody>
      </p:sp>
      <p:cxnSp>
        <p:nvCxnSpPr>
          <p:cNvPr id="65" name="Straight Arrow Connector 64">
            <a:extLst>
              <a:ext uri="{FF2B5EF4-FFF2-40B4-BE49-F238E27FC236}">
                <a16:creationId xmlns:a16="http://schemas.microsoft.com/office/drawing/2014/main" id="{53C9E45E-AF45-7A4F-B72A-BE9F1A1A31B8}"/>
              </a:ext>
            </a:extLst>
          </p:cNvPr>
          <p:cNvCxnSpPr>
            <a:cxnSpLocks/>
          </p:cNvCxnSpPr>
          <p:nvPr/>
        </p:nvCxnSpPr>
        <p:spPr>
          <a:xfrm flipH="1">
            <a:off x="10493234" y="3932965"/>
            <a:ext cx="175399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2" name="Picture 1">
            <a:extLst>
              <a:ext uri="{FF2B5EF4-FFF2-40B4-BE49-F238E27FC236}">
                <a16:creationId xmlns:a16="http://schemas.microsoft.com/office/drawing/2014/main" id="{7E8BD412-A797-334D-A3CD-3EDCCCBEC11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58069" y="2203788"/>
            <a:ext cx="3542553" cy="255408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66CA12B0-AAB4-BF4A-B9B0-F4E762F5F44E}"/>
              </a:ext>
            </a:extLst>
          </p:cNvPr>
          <p:cNvSpPr txBox="1"/>
          <p:nvPr/>
        </p:nvSpPr>
        <p:spPr>
          <a:xfrm rot="16200000">
            <a:off x="2487809" y="1849526"/>
            <a:ext cx="5148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Input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06DF240-0D0A-8B4F-888C-38AD90314DA5}"/>
              </a:ext>
            </a:extLst>
          </p:cNvPr>
          <p:cNvSpPr txBox="1"/>
          <p:nvPr/>
        </p:nvSpPr>
        <p:spPr>
          <a:xfrm rot="16200000">
            <a:off x="2530103" y="1723690"/>
            <a:ext cx="7665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Unbound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2D94BF3-F5A5-EF43-923E-AEA91CF2A2EE}"/>
              </a:ext>
            </a:extLst>
          </p:cNvPr>
          <p:cNvSpPr txBox="1"/>
          <p:nvPr/>
        </p:nvSpPr>
        <p:spPr>
          <a:xfrm rot="16200000">
            <a:off x="2641448" y="1650721"/>
            <a:ext cx="9204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/10 Bound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CE353EF-EA47-FB42-B1E4-5EB72D3CCF11}"/>
              </a:ext>
            </a:extLst>
          </p:cNvPr>
          <p:cNvSpPr txBox="1"/>
          <p:nvPr/>
        </p:nvSpPr>
        <p:spPr>
          <a:xfrm rot="16200000">
            <a:off x="2984677" y="1805658"/>
            <a:ext cx="5902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Bound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A3F3CB29-2874-C54F-BC97-177F41F7EA52}"/>
              </a:ext>
            </a:extLst>
          </p:cNvPr>
          <p:cNvSpPr txBox="1"/>
          <p:nvPr/>
        </p:nvSpPr>
        <p:spPr>
          <a:xfrm rot="16200000">
            <a:off x="3288324" y="1857606"/>
            <a:ext cx="5148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Input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0A47106C-C153-FC4D-8CAF-A3F18B2C154C}"/>
              </a:ext>
            </a:extLst>
          </p:cNvPr>
          <p:cNvSpPr txBox="1"/>
          <p:nvPr/>
        </p:nvSpPr>
        <p:spPr>
          <a:xfrm rot="16200000">
            <a:off x="3330618" y="1731770"/>
            <a:ext cx="7665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Unbound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44AB2CF3-FF4A-E04A-80FA-4A32DF4254A1}"/>
              </a:ext>
            </a:extLst>
          </p:cNvPr>
          <p:cNvSpPr txBox="1"/>
          <p:nvPr/>
        </p:nvSpPr>
        <p:spPr>
          <a:xfrm rot="16200000">
            <a:off x="3441963" y="1658801"/>
            <a:ext cx="9204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/10 Bound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2F46D80F-C234-344B-A16E-65AE6AED1EB6}"/>
              </a:ext>
            </a:extLst>
          </p:cNvPr>
          <p:cNvSpPr txBox="1"/>
          <p:nvPr/>
        </p:nvSpPr>
        <p:spPr>
          <a:xfrm rot="16200000">
            <a:off x="3785192" y="1813738"/>
            <a:ext cx="5902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Bound</a:t>
            </a:r>
          </a:p>
        </p:txBody>
      </p:sp>
      <p:cxnSp>
        <p:nvCxnSpPr>
          <p:cNvPr id="124" name="Straight Connector 123">
            <a:extLst>
              <a:ext uri="{FF2B5EF4-FFF2-40B4-BE49-F238E27FC236}">
                <a16:creationId xmlns:a16="http://schemas.microsoft.com/office/drawing/2014/main" id="{E4461CA7-71C0-BC45-9207-8C807340CC41}"/>
              </a:ext>
            </a:extLst>
          </p:cNvPr>
          <p:cNvCxnSpPr>
            <a:cxnSpLocks/>
          </p:cNvCxnSpPr>
          <p:nvPr/>
        </p:nvCxnSpPr>
        <p:spPr>
          <a:xfrm>
            <a:off x="3419571" y="1186444"/>
            <a:ext cx="0" cy="101734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FBE29BA6-0F06-E747-904B-6D86E70AABA0}"/>
              </a:ext>
            </a:extLst>
          </p:cNvPr>
          <p:cNvSpPr txBox="1"/>
          <p:nvPr/>
        </p:nvSpPr>
        <p:spPr>
          <a:xfrm>
            <a:off x="3374526" y="1153708"/>
            <a:ext cx="1221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Negative </a:t>
            </a:r>
            <a:r>
              <a:rPr lang="en-US" sz="1200" dirty="0" smtClean="0"/>
              <a:t>Control</a:t>
            </a:r>
            <a:endParaRPr lang="en-US" sz="1200" dirty="0"/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F888F756-581D-CB4E-84FF-8168A002FBF3}"/>
              </a:ext>
            </a:extLst>
          </p:cNvPr>
          <p:cNvSpPr txBox="1"/>
          <p:nvPr/>
        </p:nvSpPr>
        <p:spPr>
          <a:xfrm rot="16200000">
            <a:off x="8582445" y="1841446"/>
            <a:ext cx="5148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Input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2772A467-9A5A-5C4F-AC49-AD567972509C}"/>
              </a:ext>
            </a:extLst>
          </p:cNvPr>
          <p:cNvSpPr txBox="1"/>
          <p:nvPr/>
        </p:nvSpPr>
        <p:spPr>
          <a:xfrm rot="16200000">
            <a:off x="8650139" y="1715610"/>
            <a:ext cx="7665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Unbound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71C83FF6-8B54-8540-884A-102C29D76210}"/>
              </a:ext>
            </a:extLst>
          </p:cNvPr>
          <p:cNvSpPr txBox="1"/>
          <p:nvPr/>
        </p:nvSpPr>
        <p:spPr>
          <a:xfrm rot="16200000">
            <a:off x="8774184" y="1642641"/>
            <a:ext cx="9204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/10 Bound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055C56E3-6A8B-9D40-8CB1-049F8F5871DD}"/>
              </a:ext>
            </a:extLst>
          </p:cNvPr>
          <p:cNvSpPr txBox="1"/>
          <p:nvPr/>
        </p:nvSpPr>
        <p:spPr>
          <a:xfrm rot="16200000">
            <a:off x="9117413" y="1797578"/>
            <a:ext cx="5902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Bound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0C08D505-DF93-D34B-A96D-22452F2E333E}"/>
              </a:ext>
            </a:extLst>
          </p:cNvPr>
          <p:cNvSpPr txBox="1"/>
          <p:nvPr/>
        </p:nvSpPr>
        <p:spPr>
          <a:xfrm rot="16200000">
            <a:off x="9382960" y="1849526"/>
            <a:ext cx="5148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Input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93733CB0-D784-244F-9C77-2893801E0976}"/>
              </a:ext>
            </a:extLst>
          </p:cNvPr>
          <p:cNvSpPr txBox="1"/>
          <p:nvPr/>
        </p:nvSpPr>
        <p:spPr>
          <a:xfrm rot="16200000">
            <a:off x="9425254" y="1723690"/>
            <a:ext cx="7665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Unbound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A5560066-2613-134F-8563-F4882DB2135D}"/>
              </a:ext>
            </a:extLst>
          </p:cNvPr>
          <p:cNvSpPr txBox="1"/>
          <p:nvPr/>
        </p:nvSpPr>
        <p:spPr>
          <a:xfrm rot="16200000">
            <a:off x="9536599" y="1650721"/>
            <a:ext cx="9204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/10 Bound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EBEFA767-6C06-4142-A06B-6B725D6FF78E}"/>
              </a:ext>
            </a:extLst>
          </p:cNvPr>
          <p:cNvSpPr txBox="1"/>
          <p:nvPr/>
        </p:nvSpPr>
        <p:spPr>
          <a:xfrm rot="16200000">
            <a:off x="9879828" y="1805658"/>
            <a:ext cx="5902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Bound</a:t>
            </a:r>
          </a:p>
        </p:txBody>
      </p:sp>
      <p:cxnSp>
        <p:nvCxnSpPr>
          <p:cNvPr id="134" name="Straight Connector 133">
            <a:extLst>
              <a:ext uri="{FF2B5EF4-FFF2-40B4-BE49-F238E27FC236}">
                <a16:creationId xmlns:a16="http://schemas.microsoft.com/office/drawing/2014/main" id="{525B8427-9500-2C45-99E2-5D04FBA552FD}"/>
              </a:ext>
            </a:extLst>
          </p:cNvPr>
          <p:cNvCxnSpPr>
            <a:cxnSpLocks/>
          </p:cNvCxnSpPr>
          <p:nvPr/>
        </p:nvCxnSpPr>
        <p:spPr>
          <a:xfrm>
            <a:off x="9539607" y="1178364"/>
            <a:ext cx="0" cy="101734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4" name="Picture 23">
            <a:extLst>
              <a:ext uri="{FF2B5EF4-FFF2-40B4-BE49-F238E27FC236}">
                <a16:creationId xmlns:a16="http://schemas.microsoft.com/office/drawing/2014/main" id="{522E2D2A-A4D4-F94D-B114-136D3CF51F0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93541" y="2203788"/>
            <a:ext cx="3572552" cy="252936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2" name="Rectangle 31">
            <a:extLst>
              <a:ext uri="{FF2B5EF4-FFF2-40B4-BE49-F238E27FC236}">
                <a16:creationId xmlns:a16="http://schemas.microsoft.com/office/drawing/2014/main" id="{7DC40900-D20F-4C46-8945-B97CD2527DB4}"/>
              </a:ext>
            </a:extLst>
          </p:cNvPr>
          <p:cNvSpPr/>
          <p:nvPr/>
        </p:nvSpPr>
        <p:spPr>
          <a:xfrm>
            <a:off x="2591999" y="907088"/>
            <a:ext cx="166782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/>
              <a:t>FLAG</a:t>
            </a:r>
            <a:r>
              <a:rPr lang="en-US" sz="1200" baseline="-25000" dirty="0" smtClean="0"/>
              <a:t>2</a:t>
            </a:r>
            <a:r>
              <a:rPr lang="en-US" sz="1200" dirty="0" smtClean="0"/>
              <a:t> Pull-down Assays</a:t>
            </a:r>
            <a:endParaRPr lang="en-US" sz="1200" dirty="0"/>
          </a:p>
        </p:txBody>
      </p:sp>
      <p:cxnSp>
        <p:nvCxnSpPr>
          <p:cNvPr id="33" name="Straight Connector 32"/>
          <p:cNvCxnSpPr/>
          <p:nvPr/>
        </p:nvCxnSpPr>
        <p:spPr>
          <a:xfrm>
            <a:off x="2659728" y="1180912"/>
            <a:ext cx="18288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FBE29BA6-0F06-E747-904B-6D86E70AABA0}"/>
              </a:ext>
            </a:extLst>
          </p:cNvPr>
          <p:cNvSpPr txBox="1"/>
          <p:nvPr/>
        </p:nvSpPr>
        <p:spPr>
          <a:xfrm>
            <a:off x="9490400" y="1147084"/>
            <a:ext cx="1221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Negative </a:t>
            </a:r>
            <a:r>
              <a:rPr lang="en-US" sz="1200" dirty="0" smtClean="0"/>
              <a:t>Control</a:t>
            </a:r>
            <a:endParaRPr lang="en-US" sz="1200" dirty="0"/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7DC40900-D20F-4C46-8945-B97CD2527DB4}"/>
              </a:ext>
            </a:extLst>
          </p:cNvPr>
          <p:cNvSpPr/>
          <p:nvPr/>
        </p:nvSpPr>
        <p:spPr>
          <a:xfrm>
            <a:off x="8699922" y="900464"/>
            <a:ext cx="166782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/>
              <a:t>FLAG</a:t>
            </a:r>
            <a:r>
              <a:rPr lang="en-US" sz="1200" baseline="-25000" dirty="0" smtClean="0"/>
              <a:t>2</a:t>
            </a:r>
            <a:r>
              <a:rPr lang="en-US" sz="1200" dirty="0" smtClean="0"/>
              <a:t> Pull-down Assays</a:t>
            </a:r>
            <a:endParaRPr lang="en-US" sz="1200" dirty="0"/>
          </a:p>
        </p:txBody>
      </p:sp>
      <p:cxnSp>
        <p:nvCxnSpPr>
          <p:cNvPr id="38" name="Straight Connector 37"/>
          <p:cNvCxnSpPr/>
          <p:nvPr/>
        </p:nvCxnSpPr>
        <p:spPr>
          <a:xfrm>
            <a:off x="8767651" y="1174288"/>
            <a:ext cx="18288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2404060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1DCA1F20-7AF5-2740-AD44-78AE94E9B766}"/>
              </a:ext>
            </a:extLst>
          </p:cNvPr>
          <p:cNvSpPr/>
          <p:nvPr/>
        </p:nvSpPr>
        <p:spPr>
          <a:xfrm>
            <a:off x="164749" y="3280122"/>
            <a:ext cx="78034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αSpoIVF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296322B-6CFF-5349-9381-3E568CA58DA3}"/>
              </a:ext>
            </a:extLst>
          </p:cNvPr>
          <p:cNvSpPr txBox="1"/>
          <p:nvPr/>
        </p:nvSpPr>
        <p:spPr>
          <a:xfrm>
            <a:off x="4634495" y="3418621"/>
            <a:ext cx="693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poIVF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C287B8C-9F50-9D44-8A3A-794FE338EFBF}"/>
              </a:ext>
            </a:extLst>
          </p:cNvPr>
          <p:cNvSpPr txBox="1"/>
          <p:nvPr/>
        </p:nvSpPr>
        <p:spPr>
          <a:xfrm>
            <a:off x="10633469" y="3434523"/>
            <a:ext cx="9781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GFPΔ27BofA</a:t>
            </a: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20490A5F-4FA6-BA46-8F34-582166363CBC}"/>
              </a:ext>
            </a:extLst>
          </p:cNvPr>
          <p:cNvCxnSpPr>
            <a:cxnSpLocks/>
          </p:cNvCxnSpPr>
          <p:nvPr/>
        </p:nvCxnSpPr>
        <p:spPr>
          <a:xfrm flipH="1">
            <a:off x="10517494" y="3580974"/>
            <a:ext cx="175399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77F2994D-2FC1-F540-8139-4E72CF570D2C}"/>
              </a:ext>
            </a:extLst>
          </p:cNvPr>
          <p:cNvCxnSpPr>
            <a:cxnSpLocks/>
          </p:cNvCxnSpPr>
          <p:nvPr/>
        </p:nvCxnSpPr>
        <p:spPr>
          <a:xfrm flipH="1">
            <a:off x="4508630" y="3557122"/>
            <a:ext cx="175399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" name="Rectangle 13">
            <a:extLst>
              <a:ext uri="{FF2B5EF4-FFF2-40B4-BE49-F238E27FC236}">
                <a16:creationId xmlns:a16="http://schemas.microsoft.com/office/drawing/2014/main" id="{0372DC75-64B6-644B-BC6A-1E92C7F82F2F}"/>
              </a:ext>
            </a:extLst>
          </p:cNvPr>
          <p:cNvSpPr/>
          <p:nvPr/>
        </p:nvSpPr>
        <p:spPr>
          <a:xfrm>
            <a:off x="6346706" y="3280122"/>
            <a:ext cx="51969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α</a:t>
            </a:r>
            <a:r>
              <a:rPr lang="en-US" sz="1200" dirty="0">
                <a:solidFill>
                  <a:prstClr val="black"/>
                </a:solidFill>
                <a:cs typeface="Arial" panose="020B0604020202020204" pitchFamily="34" charset="0"/>
              </a:rPr>
              <a:t>GFP</a:t>
            </a:r>
            <a:endParaRPr lang="en-US" sz="12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DBFA43F-9423-FC44-A584-C966D9898B10}"/>
              </a:ext>
            </a:extLst>
          </p:cNvPr>
          <p:cNvSpPr txBox="1"/>
          <p:nvPr/>
        </p:nvSpPr>
        <p:spPr>
          <a:xfrm rot="16200000">
            <a:off x="2487809" y="1849526"/>
            <a:ext cx="5148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Input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4170EE3-1DCD-BD4A-9266-CF057FBCE940}"/>
              </a:ext>
            </a:extLst>
          </p:cNvPr>
          <p:cNvSpPr txBox="1"/>
          <p:nvPr/>
        </p:nvSpPr>
        <p:spPr>
          <a:xfrm rot="16200000">
            <a:off x="2530103" y="1723690"/>
            <a:ext cx="7665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Unbound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120BDC9-0776-D448-A5C0-1DC624F6B351}"/>
              </a:ext>
            </a:extLst>
          </p:cNvPr>
          <p:cNvSpPr txBox="1"/>
          <p:nvPr/>
        </p:nvSpPr>
        <p:spPr>
          <a:xfrm rot="16200000">
            <a:off x="2641448" y="1650721"/>
            <a:ext cx="9204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/10 Bound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009EC85-0B63-664B-8359-020865159156}"/>
              </a:ext>
            </a:extLst>
          </p:cNvPr>
          <p:cNvSpPr txBox="1"/>
          <p:nvPr/>
        </p:nvSpPr>
        <p:spPr>
          <a:xfrm rot="16200000">
            <a:off x="2984677" y="1805658"/>
            <a:ext cx="5902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Bound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659AF00-5E9E-C744-8598-A16C4E932A2E}"/>
              </a:ext>
            </a:extLst>
          </p:cNvPr>
          <p:cNvSpPr txBox="1"/>
          <p:nvPr/>
        </p:nvSpPr>
        <p:spPr>
          <a:xfrm rot="16200000">
            <a:off x="3288324" y="1857606"/>
            <a:ext cx="5148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Input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728444F-D404-8A41-B5D9-836FE61A1DFC}"/>
              </a:ext>
            </a:extLst>
          </p:cNvPr>
          <p:cNvSpPr txBox="1"/>
          <p:nvPr/>
        </p:nvSpPr>
        <p:spPr>
          <a:xfrm rot="16200000">
            <a:off x="3330618" y="1731770"/>
            <a:ext cx="7665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Unbound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7670F71-CCF0-F84F-9E47-542680AED1E0}"/>
              </a:ext>
            </a:extLst>
          </p:cNvPr>
          <p:cNvSpPr txBox="1"/>
          <p:nvPr/>
        </p:nvSpPr>
        <p:spPr>
          <a:xfrm rot="16200000">
            <a:off x="3441963" y="1658801"/>
            <a:ext cx="9204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/10 Bound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7037D99-DF39-C740-8B81-2279A181F3BD}"/>
              </a:ext>
            </a:extLst>
          </p:cNvPr>
          <p:cNvSpPr txBox="1"/>
          <p:nvPr/>
        </p:nvSpPr>
        <p:spPr>
          <a:xfrm rot="16200000">
            <a:off x="3785192" y="1813738"/>
            <a:ext cx="5902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Bound</a:t>
            </a: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53085BF8-CFAE-7C47-88EC-4CC5368393E2}"/>
              </a:ext>
            </a:extLst>
          </p:cNvPr>
          <p:cNvCxnSpPr>
            <a:cxnSpLocks/>
          </p:cNvCxnSpPr>
          <p:nvPr/>
        </p:nvCxnSpPr>
        <p:spPr>
          <a:xfrm>
            <a:off x="3419571" y="1186444"/>
            <a:ext cx="0" cy="101734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4EB9FF15-0651-8842-9C42-08102085C865}"/>
              </a:ext>
            </a:extLst>
          </p:cNvPr>
          <p:cNvSpPr txBox="1"/>
          <p:nvPr/>
        </p:nvSpPr>
        <p:spPr>
          <a:xfrm rot="16200000">
            <a:off x="8582445" y="1841446"/>
            <a:ext cx="5148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Input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B39D0CC-7257-494B-ACCF-2A61206F11B9}"/>
              </a:ext>
            </a:extLst>
          </p:cNvPr>
          <p:cNvSpPr txBox="1"/>
          <p:nvPr/>
        </p:nvSpPr>
        <p:spPr>
          <a:xfrm rot="16200000">
            <a:off x="8650139" y="1715610"/>
            <a:ext cx="7665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Unbound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0583D0F-9971-A849-BC70-E880794427C9}"/>
              </a:ext>
            </a:extLst>
          </p:cNvPr>
          <p:cNvSpPr txBox="1"/>
          <p:nvPr/>
        </p:nvSpPr>
        <p:spPr>
          <a:xfrm rot="16200000">
            <a:off x="8774184" y="1642641"/>
            <a:ext cx="9204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/10 Bound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8697AA92-C992-D04D-92F8-B2E75DAADCB0}"/>
              </a:ext>
            </a:extLst>
          </p:cNvPr>
          <p:cNvSpPr txBox="1"/>
          <p:nvPr/>
        </p:nvSpPr>
        <p:spPr>
          <a:xfrm rot="16200000">
            <a:off x="9117413" y="1797578"/>
            <a:ext cx="5902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Bound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63C9E79-7BBA-1C49-805F-48B5B0375196}"/>
              </a:ext>
            </a:extLst>
          </p:cNvPr>
          <p:cNvSpPr txBox="1"/>
          <p:nvPr/>
        </p:nvSpPr>
        <p:spPr>
          <a:xfrm rot="16200000">
            <a:off x="9382960" y="1849526"/>
            <a:ext cx="5148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Input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A51C0EAE-9FB9-774E-AEE9-83589027EFC2}"/>
              </a:ext>
            </a:extLst>
          </p:cNvPr>
          <p:cNvSpPr txBox="1"/>
          <p:nvPr/>
        </p:nvSpPr>
        <p:spPr>
          <a:xfrm rot="16200000">
            <a:off x="9425254" y="1723690"/>
            <a:ext cx="7665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Unbound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933B6F04-BDDE-634C-96AE-CDB474A457A3}"/>
              </a:ext>
            </a:extLst>
          </p:cNvPr>
          <p:cNvSpPr txBox="1"/>
          <p:nvPr/>
        </p:nvSpPr>
        <p:spPr>
          <a:xfrm rot="16200000">
            <a:off x="9536599" y="1650721"/>
            <a:ext cx="9204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/10 Bound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88A7118-41CC-5645-A2F0-29330BDB4AB5}"/>
              </a:ext>
            </a:extLst>
          </p:cNvPr>
          <p:cNvSpPr txBox="1"/>
          <p:nvPr/>
        </p:nvSpPr>
        <p:spPr>
          <a:xfrm rot="16200000">
            <a:off x="9879828" y="1805658"/>
            <a:ext cx="5902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Bound</a:t>
            </a:r>
          </a:p>
        </p:txBody>
      </p: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AA86E46A-6BDA-7A44-B6EA-22AFDF643818}"/>
              </a:ext>
            </a:extLst>
          </p:cNvPr>
          <p:cNvCxnSpPr>
            <a:cxnSpLocks/>
          </p:cNvCxnSpPr>
          <p:nvPr/>
        </p:nvCxnSpPr>
        <p:spPr>
          <a:xfrm>
            <a:off x="9539607" y="1178364"/>
            <a:ext cx="0" cy="101734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0" name="Picture 39">
            <a:extLst>
              <a:ext uri="{FF2B5EF4-FFF2-40B4-BE49-F238E27FC236}">
                <a16:creationId xmlns:a16="http://schemas.microsoft.com/office/drawing/2014/main" id="{56E939A7-5197-114C-8C1C-CC714D01D9D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34312" y="2195708"/>
            <a:ext cx="3558807" cy="245711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40D71487-9606-F545-8D3F-3561EB59064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33172" y="2195708"/>
            <a:ext cx="3553909" cy="255395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9" name="TextBox 38">
            <a:extLst>
              <a:ext uri="{FF2B5EF4-FFF2-40B4-BE49-F238E27FC236}">
                <a16:creationId xmlns:a16="http://schemas.microsoft.com/office/drawing/2014/main" id="{FBE29BA6-0F06-E747-904B-6D86E70AABA0}"/>
              </a:ext>
            </a:extLst>
          </p:cNvPr>
          <p:cNvSpPr txBox="1"/>
          <p:nvPr/>
        </p:nvSpPr>
        <p:spPr>
          <a:xfrm>
            <a:off x="9490400" y="1147084"/>
            <a:ext cx="1221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Negative </a:t>
            </a:r>
            <a:r>
              <a:rPr lang="en-US" sz="1200" dirty="0" smtClean="0"/>
              <a:t>Control</a:t>
            </a:r>
            <a:endParaRPr lang="en-US" sz="1200" dirty="0"/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7DC40900-D20F-4C46-8945-B97CD2527DB4}"/>
              </a:ext>
            </a:extLst>
          </p:cNvPr>
          <p:cNvSpPr/>
          <p:nvPr/>
        </p:nvSpPr>
        <p:spPr>
          <a:xfrm>
            <a:off x="8699922" y="900464"/>
            <a:ext cx="166782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/>
              <a:t>FLAG</a:t>
            </a:r>
            <a:r>
              <a:rPr lang="en-US" sz="1200" baseline="-25000" dirty="0" smtClean="0"/>
              <a:t>2</a:t>
            </a:r>
            <a:r>
              <a:rPr lang="en-US" sz="1200" dirty="0" smtClean="0"/>
              <a:t> Pull-down Assays</a:t>
            </a:r>
            <a:endParaRPr lang="en-US" sz="1200" dirty="0"/>
          </a:p>
        </p:txBody>
      </p:sp>
      <p:cxnSp>
        <p:nvCxnSpPr>
          <p:cNvPr id="43" name="Straight Connector 42"/>
          <p:cNvCxnSpPr/>
          <p:nvPr/>
        </p:nvCxnSpPr>
        <p:spPr>
          <a:xfrm>
            <a:off x="8767651" y="1174288"/>
            <a:ext cx="18288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FBE29BA6-0F06-E747-904B-6D86E70AABA0}"/>
              </a:ext>
            </a:extLst>
          </p:cNvPr>
          <p:cNvSpPr txBox="1"/>
          <p:nvPr/>
        </p:nvSpPr>
        <p:spPr>
          <a:xfrm>
            <a:off x="3408977" y="1148409"/>
            <a:ext cx="1221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Negative </a:t>
            </a:r>
            <a:r>
              <a:rPr lang="en-US" sz="1200" dirty="0" smtClean="0"/>
              <a:t>Control</a:t>
            </a:r>
            <a:endParaRPr lang="en-US" sz="1200" dirty="0"/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7DC40900-D20F-4C46-8945-B97CD2527DB4}"/>
              </a:ext>
            </a:extLst>
          </p:cNvPr>
          <p:cNvSpPr/>
          <p:nvPr/>
        </p:nvSpPr>
        <p:spPr>
          <a:xfrm>
            <a:off x="2618499" y="901789"/>
            <a:ext cx="166782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/>
              <a:t>FLAG</a:t>
            </a:r>
            <a:r>
              <a:rPr lang="en-US" sz="1200" baseline="-25000" dirty="0" smtClean="0"/>
              <a:t>2</a:t>
            </a:r>
            <a:r>
              <a:rPr lang="en-US" sz="1200" dirty="0" smtClean="0"/>
              <a:t> Pull-down Assays</a:t>
            </a:r>
            <a:endParaRPr lang="en-US" sz="1200" dirty="0"/>
          </a:p>
        </p:txBody>
      </p:sp>
      <p:cxnSp>
        <p:nvCxnSpPr>
          <p:cNvPr id="46" name="Straight Connector 45"/>
          <p:cNvCxnSpPr/>
          <p:nvPr/>
        </p:nvCxnSpPr>
        <p:spPr>
          <a:xfrm>
            <a:off x="2686228" y="1175613"/>
            <a:ext cx="18288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01896849-E0B2-574E-BB2A-A69F79EAE9AB}"/>
              </a:ext>
            </a:extLst>
          </p:cNvPr>
          <p:cNvCxnSpPr>
            <a:cxnSpLocks/>
          </p:cNvCxnSpPr>
          <p:nvPr/>
        </p:nvCxnSpPr>
        <p:spPr>
          <a:xfrm>
            <a:off x="4539642" y="3612344"/>
            <a:ext cx="0" cy="18288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6BCD5203-60D4-E247-BDB1-830A0CCD99FD}"/>
              </a:ext>
            </a:extLst>
          </p:cNvPr>
          <p:cNvCxnSpPr/>
          <p:nvPr/>
        </p:nvCxnSpPr>
        <p:spPr>
          <a:xfrm>
            <a:off x="4539647" y="3696642"/>
            <a:ext cx="21242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C08E15E4-4EF8-054A-98DF-AA3201AC65A4}"/>
              </a:ext>
            </a:extLst>
          </p:cNvPr>
          <p:cNvSpPr txBox="1"/>
          <p:nvPr/>
        </p:nvSpPr>
        <p:spPr>
          <a:xfrm>
            <a:off x="4705920" y="3557543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A4274745-B673-1445-8FC1-E5F8562CBAD0}"/>
              </a:ext>
            </a:extLst>
          </p:cNvPr>
          <p:cNvCxnSpPr/>
          <p:nvPr/>
        </p:nvCxnSpPr>
        <p:spPr>
          <a:xfrm flipH="1">
            <a:off x="10522049" y="3716132"/>
            <a:ext cx="252926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18577AA3-BB91-1C45-BB77-67D1C769A887}"/>
              </a:ext>
            </a:extLst>
          </p:cNvPr>
          <p:cNvSpPr txBox="1"/>
          <p:nvPr/>
        </p:nvSpPr>
        <p:spPr>
          <a:xfrm>
            <a:off x="10730997" y="3571960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*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06924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2C5B878757C6144B104C5E4029E0BB6" ma:contentTypeVersion="14" ma:contentTypeDescription="Create a new document." ma:contentTypeScope="" ma:versionID="9f688f900531a4236b6da98bf3cb268f">
  <xsd:schema xmlns:xsd="http://www.w3.org/2001/XMLSchema" xmlns:xs="http://www.w3.org/2001/XMLSchema" xmlns:p="http://schemas.microsoft.com/office/2006/metadata/properties" xmlns:ns3="0b01a07b-8d13-4cb5-9d22-64822278069e" xmlns:ns4="198a9f0d-948e-4f5a-af70-f6d2f30972cd" targetNamespace="http://schemas.microsoft.com/office/2006/metadata/properties" ma:root="true" ma:fieldsID="c04d3e0e4baedd5a0de5ec8817e1430b" ns3:_="" ns4:_="">
    <xsd:import namespace="0b01a07b-8d13-4cb5-9d22-64822278069e"/>
    <xsd:import namespace="198a9f0d-948e-4f5a-af70-f6d2f30972cd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3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b01a07b-8d13-4cb5-9d22-64822278069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  <xsd:element name="MediaLengthInSeconds" ma:index="21" nillable="true" ma:displayName="Length (seconds)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98a9f0d-948e-4f5a-af70-f6d2f30972cd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0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F1E2D3EE-4F61-4410-92C8-B8BA709BB9A3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b01a07b-8d13-4cb5-9d22-64822278069e"/>
    <ds:schemaRef ds:uri="198a9f0d-948e-4f5a-af70-f6d2f30972cd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CC5C2763-9D99-4005-A7D1-0F05CCF47D31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36BA6182-3A29-45F7-9B1C-ACF27B3A4F26}">
  <ds:schemaRefs>
    <ds:schemaRef ds:uri="http://www.w3.org/XML/1998/namespace"/>
    <ds:schemaRef ds:uri="http://schemas.microsoft.com/office/2006/metadata/properties"/>
    <ds:schemaRef ds:uri="http://schemas.microsoft.com/office/infopath/2007/PartnerControls"/>
    <ds:schemaRef ds:uri="http://purl.org/dc/elements/1.1/"/>
    <ds:schemaRef ds:uri="http://purl.org/dc/dcmitype/"/>
    <ds:schemaRef ds:uri="http://schemas.openxmlformats.org/package/2006/metadata/core-properties"/>
    <ds:schemaRef ds:uri="http://schemas.microsoft.com/office/2006/documentManagement/types"/>
    <ds:schemaRef ds:uri="198a9f0d-948e-4f5a-af70-f6d2f30972cd"/>
    <ds:schemaRef ds:uri="0b01a07b-8d13-4cb5-9d22-64822278069e"/>
    <ds:schemaRef ds:uri="http://purl.org/dc/terms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39</TotalTime>
  <Words>71</Words>
  <Application>Microsoft Office PowerPoint</Application>
  <PresentationFormat>Widescreen</PresentationFormat>
  <Paragraphs>5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Lee Kroos</cp:lastModifiedBy>
  <cp:revision>9</cp:revision>
  <dcterms:created xsi:type="dcterms:W3CDTF">2021-10-03T13:58:10Z</dcterms:created>
  <dcterms:modified xsi:type="dcterms:W3CDTF">2021-10-06T15:27:1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2C5B878757C6144B104C5E4029E0BB6</vt:lpwstr>
  </property>
</Properties>
</file>